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43351-C2C3-4248-BE88-B2CE40DC9A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D5225-6ECA-4BCE-9264-9B8DB103F7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C99D3-B289-46AB-808D-76849A260F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B4691-6599-4661-A691-15A7746077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2635C7-AB37-4176-9788-AEE2AC4E95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43E22A-9375-4BAC-A575-96AC15F9FA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134B50-E075-4DB3-B584-1ECBEF202B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81BCC-05CE-4DD0-A579-AC8BF9BC0F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81CEA-390F-4910-B0C3-827ECEE710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79A70-4A36-4569-9123-FB459344A5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ECC71-5D31-4FFE-9357-4106CDA4EE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FC7E9-A707-4552-856E-C7C7474B86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5AC50D-D9BC-4195-BC0B-8619AC5B6E7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upplementary Figures</a:t>
            </a:r>
            <a:br>
              <a:rPr sz="4400"/>
            </a:b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898989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2" descr=""/>
          <p:cNvPicPr/>
          <p:nvPr/>
        </p:nvPicPr>
        <p:blipFill>
          <a:blip r:embed="rId1"/>
          <a:stretch/>
        </p:blipFill>
        <p:spPr>
          <a:xfrm>
            <a:off x="455760" y="838080"/>
            <a:ext cx="3811320" cy="2971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4" name="Picture 3" descr=""/>
          <p:cNvPicPr/>
          <p:nvPr/>
        </p:nvPicPr>
        <p:blipFill>
          <a:blip r:embed="rId2"/>
          <a:stretch/>
        </p:blipFill>
        <p:spPr>
          <a:xfrm>
            <a:off x="4876920" y="838080"/>
            <a:ext cx="3741480" cy="2971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5" name="Rectangle 8"/>
          <p:cNvSpPr/>
          <p:nvPr/>
        </p:nvSpPr>
        <p:spPr>
          <a:xfrm>
            <a:off x="829800" y="4462920"/>
            <a:ext cx="6939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ry Fig. 1: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Codon quality distribution and GC content of PYC2 gene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" descr=""/>
          <p:cNvPicPr/>
          <p:nvPr/>
        </p:nvPicPr>
        <p:blipFill>
          <a:blip r:embed="rId1"/>
          <a:stretch/>
        </p:blipFill>
        <p:spPr>
          <a:xfrm>
            <a:off x="1295280" y="979560"/>
            <a:ext cx="6794640" cy="321156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2"/>
          <p:cNvSpPr/>
          <p:nvPr/>
        </p:nvSpPr>
        <p:spPr>
          <a:xfrm>
            <a:off x="-10800" y="4732200"/>
            <a:ext cx="92271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ry Fig. 2: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Agarose gel analysis for the miniprep PYC2 synthetic gene. A) synthetic gen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                                      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miniprep DNA. Lane M, 1kb DNA ladder; Lane 1 and 2, Miniprep synthetic PYC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                                      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plasmid Cl#1 and 2 B) Restriction digestion of PYC2 synthetic plasmid wit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                                      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EcoR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V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and Xho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I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restriction enzymes. Lane M, 1kb DNA ladder; Lane 1and  3,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                                      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Uncut synthetic plasmid Cl#1 and 2; Lane 2 and 4, digested synthetic plasmid Cl#1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                                      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and 2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21T07:49:29Z</dcterms:created>
  <dc:creator>sanjeev.gupta</dc:creator>
  <dc:description/>
  <dc:language>en-US</dc:language>
  <cp:lastModifiedBy>HP</cp:lastModifiedBy>
  <dcterms:modified xsi:type="dcterms:W3CDTF">2017-06-14T06:45:20Z</dcterms:modified>
  <cp:revision>20</cp:revision>
  <dc:subject/>
  <dc:title>Figures Front In Immuno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